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9" r:id="rId5"/>
    <p:sldId id="256" r:id="rId6"/>
    <p:sldId id="257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B32C85-9F3F-4AD3-A28E-7D1AA2A330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16F702-4B56-4470-A84B-FC7D9D3226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6270B3-21F3-4FC3-A309-D7529D4DD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0F39F6-C0BF-437F-B9DF-F20FAEF73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D55924F-FEF6-4AD1-AFC8-18577CB6B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9729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30CE96-D2E2-4E0B-831E-3FC67C271E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27141D2-86AA-42E5-9813-598A39A6C1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15BB95-ED29-4A72-9266-CBE6D4472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F9B645-4E8D-4B9F-934C-042E1FD23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322CA9-B2F0-4C64-9259-427386441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4553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5AB4D28-20CB-4E10-9615-A7250B877A4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BB7AA0D-E6E2-4FB2-93D5-59D6FC4EED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7B1238-1581-4431-98C2-EC956DC68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521BDF-5137-4D72-AA0A-2FCD5F6DC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21BB6-1301-4283-8242-FC2E287EEF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0224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2FF81-2EF3-445E-818B-3D84047280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178B49-AC00-4306-B304-9765D756EA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5E50C5-ED13-4825-B162-BCD40515D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9F984C-F926-418C-AFFC-A3E0DCC89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1FF730-3B02-4172-B092-E2C9DBD55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43134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CEA27-4D47-44FE-B537-4868304188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F218AE0-3566-4E78-89E7-7C67F7C767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6625B1-80CE-4D29-AF32-A1E14CA94D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0CEE59-6FE2-473B-B574-D9A97D0050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47CB18-C5DA-4E93-8468-2B2970916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5120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4E633C-423E-437C-AA87-4D53F73EE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F82498-CBEC-446C-8A50-D1C4D07D8A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8B06B2-A0A7-473C-A6A0-C0271D911A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3AC6DAB-4565-4D41-BDC0-634A800E63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95012C-5F7F-4A96-B2DC-83CEF20EB8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5C0D5D1-7014-4C83-981F-DD2CCAE227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51671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20C583-8F70-49D2-ABD2-89CC3FD63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2651EE-2E22-43B0-BEDA-02A16622CB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E6B9EDA-BC91-4C03-918B-131B20568A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43178FA-377F-4170-8C13-62B0F5E902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94419F-B927-4067-A847-89886E67200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5C09D97-A7FC-42A2-B7ED-F2823A49E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C1BA971-5B8D-418E-9A9F-1397A5F32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3D78B46-056D-4483-BCEA-7C063ED08A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1292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85D159-86B7-4D2A-B2EC-2A32595810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BABC4D7-D013-4A1C-A5A5-A13D285F0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0A46B0B-DB8F-4E4A-BD94-F150F9EE3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0FBF59C-FC06-4AD5-99BD-8A80825D9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9802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C1A0741-0883-4A16-8F9B-9E3B82F682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BB8ADE1-3E04-487B-8619-92DC3AED2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B10DD3-771B-42B0-92F8-0C9644317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82503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08EA68-B410-4B23-8E74-27C257FBC5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467451-C5C7-44AF-8986-081065A3F38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213201-F962-4EB3-8929-69B3C4F3B5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E00753-5B28-4A2E-B499-414705EDC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20512E-2835-4F09-B54B-31D4BD0015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DC961C3-3CE7-43DD-B3E6-F1EE6C3C86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8667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DF09DC-6387-4F6F-A0E7-393B12E964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82D385E-60C3-43A6-B053-8089EEE5EFC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BD96D9D-ECD1-4AE5-BA88-79D41B27BA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BFCFF1C-852B-416C-BF55-151F38FA9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A1533A-B537-487F-8051-BD711993EF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703C95-6D05-49E2-9EF8-F23325334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8622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49B2E5F-F79C-4CE2-B367-DC7984BCD2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E01551F-A9CA-4310-B102-00809C0887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4EAA6E-74ED-4D78-8827-0EC69016C7F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568C3-F7EF-4084-A884-F920C1A2767D}" type="datetimeFigureOut">
              <a:rPr lang="en-GB" smtClean="0"/>
              <a:t>28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2B968C-8A6F-4CBE-9315-03E9C4ED1BE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C7A1EF-82DC-4B4D-AF93-7432B9A972A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32011-4751-4308-9A0F-99753855200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0042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5F70E901-028C-40AE-8C42-E3E54EC935E8}"/>
              </a:ext>
            </a:extLst>
          </p:cNvPr>
          <p:cNvSpPr/>
          <p:nvPr/>
        </p:nvSpPr>
        <p:spPr>
          <a:xfrm>
            <a:off x="465055" y="566660"/>
            <a:ext cx="11393865" cy="4070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Bef>
                <a:spcPts val="1200"/>
              </a:spcBef>
              <a:spcAft>
                <a:spcPts val="0"/>
              </a:spcAft>
            </a:pPr>
            <a:r>
              <a:rPr lang="en-GB" sz="2000" b="1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2000" b="1" kern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le 1:  </a:t>
            </a:r>
            <a:r>
              <a:rPr lang="en-GB" sz="2000" b="1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Examples of APP content and the links to relevant Behaviour Change Techniques (BCTs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B298408-2376-4386-8876-B63674E0FF2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85812" y="1102468"/>
            <a:ext cx="7820376" cy="526811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58880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>
            <a:extLst>
              <a:ext uri="{FF2B5EF4-FFF2-40B4-BE49-F238E27FC236}">
                <a16:creationId xmlns:a16="http://schemas.microsoft.com/office/drawing/2014/main" id="{FF8F10FA-98FA-4F2B-9897-0C68F8DBD7CE}"/>
              </a:ext>
            </a:extLst>
          </p:cNvPr>
          <p:cNvGrpSpPr/>
          <p:nvPr/>
        </p:nvGrpSpPr>
        <p:grpSpPr>
          <a:xfrm>
            <a:off x="1241196" y="292297"/>
            <a:ext cx="9709608" cy="6273405"/>
            <a:chOff x="2422689" y="231089"/>
            <a:chExt cx="8801695" cy="5792508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6241F2D8-C71B-4160-96A0-B04EFF9E0B14}"/>
                </a:ext>
              </a:extLst>
            </p:cNvPr>
            <p:cNvGrpSpPr/>
            <p:nvPr/>
          </p:nvGrpSpPr>
          <p:grpSpPr>
            <a:xfrm>
              <a:off x="2422689" y="231089"/>
              <a:ext cx="8801695" cy="5792508"/>
              <a:chOff x="2611225" y="353637"/>
              <a:chExt cx="8801695" cy="5792508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A42592C6-6561-4417-AAC7-3D82888BB1B6}"/>
                  </a:ext>
                </a:extLst>
              </p:cNvPr>
              <p:cNvGrpSpPr/>
              <p:nvPr/>
            </p:nvGrpSpPr>
            <p:grpSpPr>
              <a:xfrm>
                <a:off x="4166648" y="353637"/>
                <a:ext cx="7246272" cy="5792508"/>
                <a:chOff x="5354425" y="551600"/>
                <a:chExt cx="7246272" cy="5792508"/>
              </a:xfrm>
            </p:grpSpPr>
            <p:pic>
              <p:nvPicPr>
                <p:cNvPr id="4" name="Picture 3">
                  <a:extLst>
                    <a:ext uri="{FF2B5EF4-FFF2-40B4-BE49-F238E27FC236}">
                      <a16:creationId xmlns:a16="http://schemas.microsoft.com/office/drawing/2014/main" id="{760FCB07-9A43-465F-81B5-731D3C7AACDF}"/>
                    </a:ext>
                  </a:extLst>
                </p:cNvPr>
                <p:cNvPicPr/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8754557" y="1426845"/>
                  <a:ext cx="1796415" cy="400431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5" name="Picture 4">
                  <a:extLst>
                    <a:ext uri="{FF2B5EF4-FFF2-40B4-BE49-F238E27FC236}">
                      <a16:creationId xmlns:a16="http://schemas.microsoft.com/office/drawing/2014/main" id="{EDE3A87F-61DB-4AF9-A6EE-4563A224B543}"/>
                    </a:ext>
                  </a:extLst>
                </p:cNvPr>
                <p:cNvPicPr/>
                <p:nvPr/>
              </p:nvPicPr>
              <p:blipFill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230966" y="551600"/>
                  <a:ext cx="2369731" cy="5095057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pic>
              <p:nvPicPr>
                <p:cNvPr id="6" name="Picture 5">
                  <a:extLst>
                    <a:ext uri="{FF2B5EF4-FFF2-40B4-BE49-F238E27FC236}">
                      <a16:creationId xmlns:a16="http://schemas.microsoft.com/office/drawing/2014/main" id="{7C28CA3C-D0F5-4450-953A-6F4168154070}"/>
                    </a:ext>
                  </a:extLst>
                </p:cNvPr>
                <p:cNvPicPr/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rot="16200000">
                  <a:off x="6365641" y="3211992"/>
                  <a:ext cx="2120900" cy="4143331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153FF0B2-349A-44BB-AB24-5B45FE9B4519}"/>
                  </a:ext>
                </a:extLst>
              </p:cNvPr>
              <p:cNvSpPr txBox="1"/>
              <p:nvPr/>
            </p:nvSpPr>
            <p:spPr>
              <a:xfrm>
                <a:off x="2611225" y="958683"/>
                <a:ext cx="5571241" cy="230832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  <a:p>
                <a:endParaRPr lang="en-GB" dirty="0"/>
              </a:p>
            </p:txBody>
          </p:sp>
        </p:grpSp>
        <p:sp>
          <p:nvSpPr>
            <p:cNvPr id="11" name="Rectangle 1">
              <a:extLst>
                <a:ext uri="{FF2B5EF4-FFF2-40B4-BE49-F238E27FC236}">
                  <a16:creationId xmlns:a16="http://schemas.microsoft.com/office/drawing/2014/main" id="{F1DE558F-87A6-4684-A4DD-66E4FF05B1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1225" y="1397227"/>
              <a:ext cx="5011166" cy="166194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152352" rIns="91440" bIns="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u="sng" strike="noStrike" cap="none" normalizeH="0" baseline="0" dirty="0">
                  <a:ln>
                    <a:noFill/>
                  </a:ln>
                  <a:solidFill>
                    <a:srgbClr val="2F5496"/>
                  </a:solidFill>
                  <a:effectLst/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Knowledge and Skills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GB" altLang="en-US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kumimoji="0" lang="en-GB" altLang="en-US" b="0" i="0" u="none" strike="noStrike" cap="none" normalizeH="0" baseline="0" dirty="0">
                  <a:ln>
                    <a:noFill/>
                  </a:ln>
                  <a:solidFill>
                    <a:srgbClr val="2F5496"/>
                  </a:solidFill>
                  <a:effectLst/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.1 Instruction on how to perform the behaviour   </a:t>
              </a:r>
              <a:endParaRPr lang="en-GB" altLang="en-US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0" i="0" u="none" strike="noStrike" cap="none" normalizeH="0" baseline="0" dirty="0">
                  <a:ln>
                    <a:noFill/>
                  </a:ln>
                  <a:solidFill>
                    <a:srgbClr val="2F5496"/>
                  </a:solidFill>
                  <a:effectLst/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6.1 Demonstration of the behaviour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GB" altLang="en-US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6.2 Social comparison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719897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AEFF742A-362D-40C2-BC6F-255975988BE4}"/>
              </a:ext>
            </a:extLst>
          </p:cNvPr>
          <p:cNvGrpSpPr/>
          <p:nvPr/>
        </p:nvGrpSpPr>
        <p:grpSpPr>
          <a:xfrm>
            <a:off x="1549924" y="681087"/>
            <a:ext cx="9327821" cy="5674935"/>
            <a:chOff x="1740817" y="543583"/>
            <a:chExt cx="9264320" cy="5574412"/>
          </a:xfrm>
        </p:grpSpPr>
        <p:sp>
          <p:nvSpPr>
            <p:cNvPr id="5" name="Rectangle 1">
              <a:extLst>
                <a:ext uri="{FF2B5EF4-FFF2-40B4-BE49-F238E27FC236}">
                  <a16:creationId xmlns:a16="http://schemas.microsoft.com/office/drawing/2014/main" id="{00D3FC6B-C851-46B5-BF2B-C689E2C609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40817" y="1485856"/>
              <a:ext cx="5528078" cy="151157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152352" rIns="91440" bIns="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u="sng" strike="noStrike" cap="none" normalizeH="0" baseline="0" dirty="0">
                  <a:ln>
                    <a:noFill/>
                  </a:ln>
                  <a:solidFill>
                    <a:srgbClr val="2F5496"/>
                  </a:solidFill>
                  <a:effectLst/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Supportive Environment 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lang="en-GB" altLang="en-US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en-US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.1 Social Support</a:t>
              </a:r>
            </a:p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GB" altLang="en-US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2.1 Restructuring the physical environment</a:t>
              </a: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GB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2719B04D-1FB9-4785-8A6A-A4809D18C2B2}"/>
                </a:ext>
              </a:extLst>
            </p:cNvPr>
            <p:cNvGrpSpPr/>
            <p:nvPr/>
          </p:nvGrpSpPr>
          <p:grpSpPr>
            <a:xfrm>
              <a:off x="6096000" y="543583"/>
              <a:ext cx="4909137" cy="5574412"/>
              <a:chOff x="5005633" y="386450"/>
              <a:chExt cx="5164158" cy="5374664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E563C818-09F2-4D46-BDE0-8114C2AB992E}"/>
                  </a:ext>
                </a:extLst>
              </p:cNvPr>
              <p:cNvPicPr/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005633" y="782425"/>
                <a:ext cx="2630078" cy="4978689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9DCB387B-BB6D-4FDA-98AD-1826547D8358}"/>
                  </a:ext>
                </a:extLst>
              </p:cNvPr>
              <p:cNvPicPr/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163397" y="386450"/>
                <a:ext cx="3006394" cy="4978689"/>
              </a:xfrm>
              <a:prstGeom prst="rect">
                <a:avLst/>
              </a:prstGeom>
              <a:noFill/>
              <a:ln>
                <a:noFill/>
              </a:ln>
            </p:spPr>
          </p:pic>
        </p:grpSp>
      </p:grpSp>
    </p:spTree>
    <p:extLst>
      <p:ext uri="{BB962C8B-B14F-4D97-AF65-F5344CB8AC3E}">
        <p14:creationId xmlns:p14="http://schemas.microsoft.com/office/powerpoint/2010/main" val="38531234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75348720-AFA3-4A16-B6DD-96AD758736CC}"/>
              </a:ext>
            </a:extLst>
          </p:cNvPr>
          <p:cNvGrpSpPr/>
          <p:nvPr/>
        </p:nvGrpSpPr>
        <p:grpSpPr>
          <a:xfrm>
            <a:off x="1668544" y="663788"/>
            <a:ext cx="8854912" cy="5944402"/>
            <a:chOff x="1906547" y="663788"/>
            <a:chExt cx="8615036" cy="5722871"/>
          </a:xfrm>
        </p:grpSpPr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825D1BC1-E9B0-497E-A670-1483643F7BC8}"/>
                </a:ext>
              </a:extLst>
            </p:cNvPr>
            <p:cNvSpPr/>
            <p:nvPr/>
          </p:nvSpPr>
          <p:spPr>
            <a:xfrm>
              <a:off x="1906547" y="1770643"/>
              <a:ext cx="5870566" cy="3284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07000"/>
                </a:lnSpc>
                <a:spcBef>
                  <a:spcPts val="1200"/>
                </a:spcBef>
                <a:spcAft>
                  <a:spcPts val="0"/>
                </a:spcAft>
              </a:pPr>
              <a:r>
                <a:rPr lang="en-GB" b="1" u="sng" kern="0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otivation / Self-efficacy</a:t>
              </a:r>
            </a:p>
            <a:p>
              <a:pPr>
                <a:spcAft>
                  <a:spcPts val="0"/>
                </a:spcAft>
              </a:pPr>
              <a:endParaRPr lang="en-GB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spcAft>
                  <a:spcPts val="0"/>
                </a:spcAft>
              </a:pPr>
              <a:r>
                <a:rPr lang="en-GB" kern="0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.1 Goal-setting (behaviour)</a:t>
              </a:r>
            </a:p>
            <a:p>
              <a:pPr>
                <a:spcAft>
                  <a:spcPts val="0"/>
                </a:spcAft>
              </a:pPr>
              <a:r>
                <a:rPr lang="en-GB" kern="0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.5 Self-monitoring of behaviour</a:t>
              </a:r>
            </a:p>
            <a:p>
              <a:pPr>
                <a:spcAft>
                  <a:spcPts val="0"/>
                </a:spcAft>
              </a:pPr>
              <a:r>
                <a:rPr lang="en-GB" kern="0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7.1 Prompts/cues</a:t>
              </a:r>
            </a:p>
            <a:p>
              <a:pPr>
                <a:lnSpc>
                  <a:spcPct val="107000"/>
                </a:lnSpc>
                <a:spcBef>
                  <a:spcPts val="1200"/>
                </a:spcBef>
                <a:spcAft>
                  <a:spcPts val="0"/>
                </a:spcAft>
              </a:pPr>
              <a:endParaRPr lang="en-GB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Bef>
                  <a:spcPts val="1200"/>
                </a:spcBef>
                <a:spcAft>
                  <a:spcPts val="0"/>
                </a:spcAft>
              </a:pPr>
              <a:endParaRPr lang="en-GB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Bef>
                  <a:spcPts val="1200"/>
                </a:spcBef>
                <a:spcAft>
                  <a:spcPts val="0"/>
                </a:spcAft>
              </a:pPr>
              <a:endParaRPr lang="en-GB" b="1" kern="0" dirty="0">
                <a:solidFill>
                  <a:srgbClr val="2F5496"/>
                </a:solidFill>
                <a:latin typeface="Calibri Light" panose="020F03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>
                <a:lnSpc>
                  <a:spcPct val="107000"/>
                </a:lnSpc>
                <a:spcBef>
                  <a:spcPts val="1200"/>
                </a:spcBef>
                <a:spcAft>
                  <a:spcPts val="0"/>
                </a:spcAft>
              </a:pPr>
              <a:r>
                <a:rPr lang="en-GB" b="1" kern="0" dirty="0">
                  <a:solidFill>
                    <a:srgbClr val="2F5496"/>
                  </a:solidFill>
                  <a:latin typeface="Calibri Light" panose="020F03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4A62A08-041E-45B1-BE3F-1E350119F895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20094" y="1001330"/>
              <a:ext cx="2473325" cy="4986779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24B62C1-B9AC-4D5B-8917-2FEA37B37E5A}"/>
                </a:ext>
              </a:extLst>
            </p:cNvPr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93590" y="663788"/>
              <a:ext cx="2927993" cy="5722871"/>
            </a:xfrm>
            <a:prstGeom prst="rect">
              <a:avLst/>
            </a:prstGeom>
            <a:noFill/>
            <a:ln>
              <a:noFill/>
            </a:ln>
          </p:spPr>
        </p:pic>
      </p:grpSp>
    </p:spTree>
    <p:extLst>
      <p:ext uri="{BB962C8B-B14F-4D97-AF65-F5344CB8AC3E}">
        <p14:creationId xmlns:p14="http://schemas.microsoft.com/office/powerpoint/2010/main" val="4116079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3E9B4DE4498A044897736DAD80F9FF5A" ma:contentTypeVersion="14" ma:contentTypeDescription="Create a new document." ma:contentTypeScope="" ma:versionID="0583895127c06d9aff8e0c7b03edf827">
  <xsd:schema xmlns:xsd="http://www.w3.org/2001/XMLSchema" xmlns:xs="http://www.w3.org/2001/XMLSchema" xmlns:p="http://schemas.microsoft.com/office/2006/metadata/properties" xmlns:ns3="806aeec0-4648-4bd5-b80c-5acf0bd9e980" xmlns:ns4="77145ffc-4c58-47e7-8ac3-3528dba46c5e" targetNamespace="http://schemas.microsoft.com/office/2006/metadata/properties" ma:root="true" ma:fieldsID="c2875f33191dd54400fc694ab501a434" ns3:_="" ns4:_="">
    <xsd:import namespace="806aeec0-4648-4bd5-b80c-5acf0bd9e980"/>
    <xsd:import namespace="77145ffc-4c58-47e7-8ac3-3528dba46c5e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EventHashCode" minOccurs="0"/>
                <xsd:element ref="ns3:MediaServiceGenerationTime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LengthInSecond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06aeec0-4648-4bd5-b80c-5acf0bd9e98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description="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description="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description="" ma:hidden="true" ma:internalName="MediaServiceDateTaken" ma:readOnly="true">
      <xsd:simpleType>
        <xsd:restriction base="dms:Text"/>
      </xsd:simpleType>
    </xsd:element>
    <xsd:element name="MediaServiceAutoTags" ma:index="11" nillable="true" ma:displayName="MediaServiceAutoTags" ma:description="" ma:internalName="MediaServiceAutoTags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Length (seconds)" ma:internalName="MediaLengthInSeconds" ma:readOnly="true">
      <xsd:simpleType>
        <xsd:restriction base="dms:Unknown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7145ffc-4c58-47e7-8ac3-3528dba46c5e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6358496-C9F1-4E06-887E-86D186747D2A}">
  <ds:schemaRefs>
    <ds:schemaRef ds:uri="http://schemas.openxmlformats.org/package/2006/metadata/core-properties"/>
    <ds:schemaRef ds:uri="http://purl.org/dc/dcmitype/"/>
    <ds:schemaRef ds:uri="http://schemas.microsoft.com/office/infopath/2007/PartnerControls"/>
    <ds:schemaRef ds:uri="77145ffc-4c58-47e7-8ac3-3528dba46c5e"/>
    <ds:schemaRef ds:uri="http://purl.org/dc/elements/1.1/"/>
    <ds:schemaRef ds:uri="http://schemas.microsoft.com/office/2006/metadata/properties"/>
    <ds:schemaRef ds:uri="http://schemas.microsoft.com/office/2006/documentManagement/types"/>
    <ds:schemaRef ds:uri="http://purl.org/dc/terms/"/>
    <ds:schemaRef ds:uri="806aeec0-4648-4bd5-b80c-5acf0bd9e980"/>
    <ds:schemaRef ds:uri="http://www.w3.org/XML/1998/namespace"/>
  </ds:schemaRefs>
</ds:datastoreItem>
</file>

<file path=customXml/itemProps2.xml><?xml version="1.0" encoding="utf-8"?>
<ds:datastoreItem xmlns:ds="http://schemas.openxmlformats.org/officeDocument/2006/customXml" ds:itemID="{0C5C7AB9-1F9D-4F3B-872F-BAFE309B463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5709C4C-C903-40A1-AF3D-B785AE9AE7A7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06aeec0-4648-4bd5-b80c-5acf0bd9e980"/>
    <ds:schemaRef ds:uri="77145ffc-4c58-47e7-8ac3-3528dba46c5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65</Words>
  <Application>Microsoft Office PowerPoint</Application>
  <PresentationFormat>Widescreen</PresentationFormat>
  <Paragraphs>2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ice Berry</dc:creator>
  <cp:lastModifiedBy>Alice Berry</cp:lastModifiedBy>
  <cp:revision>6</cp:revision>
  <dcterms:created xsi:type="dcterms:W3CDTF">2021-12-13T20:27:41Z</dcterms:created>
  <dcterms:modified xsi:type="dcterms:W3CDTF">2022-02-28T16:31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E9B4DE4498A044897736DAD80F9FF5A</vt:lpwstr>
  </property>
</Properties>
</file>